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130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6237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2873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454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5517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2102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4191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5877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0631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999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1712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6576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0818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8DE1177-A61A-7AD0-39DC-A974AD2592FC}"/>
              </a:ext>
            </a:extLst>
          </p:cNvPr>
          <p:cNvSpPr txBox="1"/>
          <p:nvPr/>
        </p:nvSpPr>
        <p:spPr>
          <a:xfrm>
            <a:off x="251860" y="5207238"/>
            <a:ext cx="8640279" cy="17502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5.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x proportional h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zards model for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FS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NBC treated with ICIs. </a:t>
            </a:r>
          </a:p>
          <a:p>
            <a:pPr algn="just">
              <a:lnSpc>
                <a:spcPct val="200000"/>
              </a:lnSpc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F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lang="zh-CN" altLang="en-US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as</a:t>
            </a:r>
            <a:r>
              <a:rPr lang="zh-CN" altLang="en-US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lotted by Cox proportional hazards model in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TNBC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Time is presented as days from the start of immunotherapy. Patients are stratified by HER-2. Blue lines: HER-2 (-); red lines, HER-2 (1+/2+).</a:t>
            </a:r>
          </a:p>
          <a:p>
            <a:pPr algn="just">
              <a:lnSpc>
                <a:spcPct val="200000"/>
              </a:lnSpc>
            </a:pP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endParaRPr lang="zh-CN" altLang="zh-CN" sz="14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7" name="图片 6" descr="图表, 直方图&#10;&#10;描述已自动生成">
            <a:extLst>
              <a:ext uri="{FF2B5EF4-FFF2-40B4-BE49-F238E27FC236}">
                <a16:creationId xmlns:a16="http://schemas.microsoft.com/office/drawing/2014/main" id="{D923580A-6EFB-61E2-7ED9-E4AA93E5D1B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76" t="16961" r="2673"/>
          <a:stretch/>
        </p:blipFill>
        <p:spPr>
          <a:xfrm>
            <a:off x="251860" y="664142"/>
            <a:ext cx="8065970" cy="44312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0370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5</TotalTime>
  <Words>59</Words>
  <Application>Microsoft Office PowerPoint</Application>
  <PresentationFormat>全屏显示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ng Dai</dc:creator>
  <cp:lastModifiedBy>Ying Dai</cp:lastModifiedBy>
  <cp:revision>6</cp:revision>
  <dcterms:created xsi:type="dcterms:W3CDTF">2023-12-11T13:09:18Z</dcterms:created>
  <dcterms:modified xsi:type="dcterms:W3CDTF">2023-12-11T14:03:57Z</dcterms:modified>
</cp:coreProperties>
</file>